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48" r:id="rId1"/>
  </p:sldMasterIdLst>
  <p:sldIdLst>
    <p:sldId id="262" r:id="rId2"/>
    <p:sldId id="263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9" autoAdjust="0"/>
    <p:restoredTop sz="94626"/>
  </p:normalViewPr>
  <p:slideViewPr>
    <p:cSldViewPr snapToGrid="0">
      <p:cViewPr varScale="1">
        <p:scale>
          <a:sx n="108" d="100"/>
          <a:sy n="108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idimohamed\Downloads\vaccination%20%2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Hepatitis B vaccination coverage by year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Hepatitis B vaccination coverage by years 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Feuil1!$A$2:$A$20</c:f>
              <c:numCache>
                <c:formatCode>General</c:formatCode>
                <c:ptCount val="19"/>
                <c:pt idx="0">
                  <c:v>2005</c:v>
                </c:pt>
                <c:pt idx="1">
                  <c:v>2006</c:v>
                </c:pt>
                <c:pt idx="2">
                  <c:v>2007</c:v>
                </c:pt>
                <c:pt idx="3">
                  <c:v>2008</c:v>
                </c:pt>
                <c:pt idx="4">
                  <c:v>2009</c:v>
                </c:pt>
                <c:pt idx="5">
                  <c:v>2010</c:v>
                </c:pt>
                <c:pt idx="6">
                  <c:v>2011</c:v>
                </c:pt>
                <c:pt idx="7">
                  <c:v>2012</c:v>
                </c:pt>
                <c:pt idx="8">
                  <c:v>2013</c:v>
                </c:pt>
                <c:pt idx="9">
                  <c:v>2014</c:v>
                </c:pt>
                <c:pt idx="10">
                  <c:v>2015</c:v>
                </c:pt>
                <c:pt idx="11">
                  <c:v>2016</c:v>
                </c:pt>
                <c:pt idx="12">
                  <c:v>2017</c:v>
                </c:pt>
                <c:pt idx="13">
                  <c:v>2018</c:v>
                </c:pt>
                <c:pt idx="14">
                  <c:v>2020</c:v>
                </c:pt>
                <c:pt idx="15">
                  <c:v>2021</c:v>
                </c:pt>
                <c:pt idx="16">
                  <c:v>2022</c:v>
                </c:pt>
                <c:pt idx="17">
                  <c:v>2023</c:v>
                </c:pt>
                <c:pt idx="18">
                  <c:v>2024</c:v>
                </c:pt>
              </c:numCache>
            </c:numRef>
          </c:cat>
          <c:val>
            <c:numRef>
              <c:f>Feuil1!$B$2:$B$20</c:f>
              <c:numCache>
                <c:formatCode>0%</c:formatCode>
                <c:ptCount val="19"/>
                <c:pt idx="0">
                  <c:v>0.42</c:v>
                </c:pt>
                <c:pt idx="1">
                  <c:v>0.68</c:v>
                </c:pt>
                <c:pt idx="2">
                  <c:v>0.74</c:v>
                </c:pt>
                <c:pt idx="3">
                  <c:v>0.74</c:v>
                </c:pt>
                <c:pt idx="4">
                  <c:v>0.64449999999999996</c:v>
                </c:pt>
                <c:pt idx="5">
                  <c:v>0.64319999999999999</c:v>
                </c:pt>
                <c:pt idx="6">
                  <c:v>0.751</c:v>
                </c:pt>
                <c:pt idx="7">
                  <c:v>0.8</c:v>
                </c:pt>
                <c:pt idx="8">
                  <c:v>0.8</c:v>
                </c:pt>
                <c:pt idx="9">
                  <c:v>0.84</c:v>
                </c:pt>
                <c:pt idx="10">
                  <c:v>0.73199999999999998</c:v>
                </c:pt>
                <c:pt idx="11">
                  <c:v>0.86</c:v>
                </c:pt>
                <c:pt idx="12">
                  <c:v>0.90049999999999997</c:v>
                </c:pt>
                <c:pt idx="13">
                  <c:v>0.90049999999999997</c:v>
                </c:pt>
                <c:pt idx="14">
                  <c:v>0.97</c:v>
                </c:pt>
                <c:pt idx="15">
                  <c:v>0.97</c:v>
                </c:pt>
                <c:pt idx="16">
                  <c:v>0.85</c:v>
                </c:pt>
                <c:pt idx="17">
                  <c:v>0.90439999999999998</c:v>
                </c:pt>
                <c:pt idx="18">
                  <c:v>0.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7C5-4688-A335-9A8D1223DE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05474040"/>
        <c:axId val="605471880"/>
      </c:lineChart>
      <c:catAx>
        <c:axId val="605474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5471880"/>
        <c:crosses val="autoZero"/>
        <c:auto val="1"/>
        <c:lblAlgn val="ctr"/>
        <c:lblOffset val="100"/>
        <c:noMultiLvlLbl val="0"/>
      </c:catAx>
      <c:valAx>
        <c:axId val="605471880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CA" sz="1400" dirty="0"/>
                  <a:t>Percent of popul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5474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253A9A-7FCE-CD3D-99C7-1FE8745903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D87364-2A5F-A96F-C13D-46B93B313E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04C582-221E-73D6-0FC0-607C94AA3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D9E502-E063-A4ED-62EB-69E81970F1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668E6F-1D99-E0E0-C4DA-B0975FC31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77155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D5B11F-B34B-6636-E3B7-A7A5CE9F7C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182645-1C13-9195-29F4-9420DCA82B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AEF0C7-733A-A22C-C17A-7D7F7431F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56F4FB-2E47-F6C2-AAE0-B4176A03D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19A3AC-1B34-20DD-3C58-EA6DF90BC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827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D6577B-0EB9-332F-AB70-1655086E96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59BC45-1BB9-E3EE-5840-3B8DBFE3FC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6FB358-65EE-DD9A-5194-254D02A08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CE40FD-9C63-D22B-AEC9-8D7CA88A2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82BE8E-D61A-9BE1-9090-B29CE81AD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834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DEBDC8-DE41-19BD-D3FC-A22F4DA1BF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B746D1-3DE6-F2C8-82BA-35FF964D2C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581A1C-704C-B503-22EE-63038AD76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16771C-23BA-4C6E-9377-4ABE50649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0E7782-6A16-82F6-B871-F221ABC8E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3865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3CDAF-4EC8-B902-F7A7-32657F4493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61753E-0437-719D-CCFC-EC42A187A8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5FE7D5-47E5-0273-7D5B-DB40516B5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164154-7294-0272-9763-59E91BFC4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E8F154-12A7-323A-D408-EA803EB5C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0291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505428-45E0-97E6-B86C-C94A9AB88C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008F81-8887-2E4B-822B-82E794BB98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9D95FC-278B-DFD4-A633-8D45A12D61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2DD10A-2D6B-E279-44E5-33A9E10EFD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AA3801-CF5F-8FB5-A490-F654C1BC8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763731-0DA2-D943-A8C4-0EAD06326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3858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52909B-6E4C-4753-AFC8-0952129C4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6BA501-1CA6-D9A1-D0AC-9744B6FF16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CE1CC3-B9DE-5F51-CA2F-687ED9AAD8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78FC2B-E244-93FB-805F-73FFB164DF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FF32C7-01DB-3515-D2B7-E6488BD13C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C95629-7FA2-B569-9291-B81E01C7C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8DFD763-A528-8474-5384-F15EF585D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AA4B87E-EBB5-CFC3-E90B-2AE043841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46938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9DE25F-C90F-7B31-7801-E7C87E96F5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E5FEEB-DA9B-1F7E-C9C4-3ECE24150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280D53-9DEF-2014-8928-C3B3C5788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32E700-C532-A3C3-2C4A-DB84BFF8C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668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7E3EE4-F585-AC1C-554C-2BD709933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5F60EC-6BEF-B718-48DC-DB71D5865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FDB698-1EB9-E79A-B579-6BA428DC8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23332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3AF5C-28F6-F50E-5979-3DC4475A94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637249-4DBE-EB5C-FF9C-BF01C15A0A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CE7368-CD65-0948-455F-C3BBF26040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7A460D-7C53-A749-8627-722280D39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F038E2-B472-1CF2-28DA-0A56DD139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707022-B807-13CE-EAE7-652680541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22717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FC5D99-2F55-AA3D-69D0-762DC5F4B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F616AFF-9E9A-9D4B-A65D-59020DC6F8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958224-D5E0-2863-FE6B-DA9507B098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51D4DF-05A2-322D-BDA0-AE8BE5119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39ECEF-9421-988F-65CB-5F0973AD7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62E94B-A8F7-8FD2-EE58-AE431E5C2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4431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320328-A8FA-F81C-DCFB-571150A91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A47F6B-95B2-9885-69FE-150CA11B42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8B2124-EA27-77F5-8516-F22C3FD533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2DF54D-5ED3-40CA-B2C2-2EE5F42F3A49}" type="datetimeFigureOut">
              <a:rPr lang="en-CA" smtClean="0"/>
              <a:t>2026-04-1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B199C-31F5-65BA-7703-322373FC85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7D0751-20E3-F910-0DE6-5D8E49DE98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2A738E-300D-463E-B092-66C392E9897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9570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4CD5C3D-185F-37D0-A9EE-389C9582BF1F}"/>
              </a:ext>
            </a:extLst>
          </p:cNvPr>
          <p:cNvSpPr txBox="1"/>
          <p:nvPr/>
        </p:nvSpPr>
        <p:spPr>
          <a:xfrm>
            <a:off x="4421293" y="2970107"/>
            <a:ext cx="42020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/>
              <a:t>Supplementary Figures/Tables</a:t>
            </a:r>
          </a:p>
        </p:txBody>
      </p:sp>
    </p:spTree>
    <p:extLst>
      <p:ext uri="{BB962C8B-B14F-4D97-AF65-F5344CB8AC3E}">
        <p14:creationId xmlns:p14="http://schemas.microsoft.com/office/powerpoint/2010/main" val="19632751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6903500-F793-70ED-5F7B-CE6BD56D21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165049"/>
              </p:ext>
            </p:extLst>
          </p:nvPr>
        </p:nvGraphicFramePr>
        <p:xfrm>
          <a:off x="254000" y="526255"/>
          <a:ext cx="7862148" cy="5803013"/>
        </p:xfrm>
        <a:graphic>
          <a:graphicData uri="http://schemas.openxmlformats.org/drawingml/2006/table">
            <a:tbl>
              <a:tblPr firstRow="1" firstCol="1" bandRow="1"/>
              <a:tblGrid>
                <a:gridCol w="1451866">
                  <a:extLst>
                    <a:ext uri="{9D8B030D-6E8A-4147-A177-3AD203B41FA5}">
                      <a16:colId xmlns:a16="http://schemas.microsoft.com/office/drawing/2014/main" val="2575344604"/>
                    </a:ext>
                  </a:extLst>
                </a:gridCol>
                <a:gridCol w="6410282">
                  <a:extLst>
                    <a:ext uri="{9D8B030D-6E8A-4147-A177-3AD203B41FA5}">
                      <a16:colId xmlns:a16="http://schemas.microsoft.com/office/drawing/2014/main" val="4213969634"/>
                    </a:ext>
                  </a:extLst>
                </a:gridCol>
              </a:tblGrid>
              <a:tr h="167538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000" kern="1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atabase</a:t>
                      </a:r>
                      <a:r>
                        <a:rPr lang="fr-FR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1000" kern="1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arched</a:t>
                      </a:r>
                      <a:r>
                        <a:rPr lang="fr-FR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endParaRPr lang="en-CA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arch terms </a:t>
                      </a:r>
                      <a:endParaRPr lang="en-CA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6250760"/>
                  </a:ext>
                </a:extLst>
              </a:tr>
              <a:tr h="150149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ubMed</a:t>
                      </a:r>
                      <a:endParaRPr lang="en-CA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buNone/>
                      </a:pP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BV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h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) OR 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HBV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pe b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"type b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"hep b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)) AND (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h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) OR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Nouakchott*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))</a:t>
                      </a:r>
                      <a:b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DV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h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) OR 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HDV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pe d" 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"type d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"hep d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)) AND (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h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) OR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Nouakchott*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))</a:t>
                      </a:r>
                      <a:b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BV-HDV co-infection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h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OR HBV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) AND 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h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 OR HDV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)) AND (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"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h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) OR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 OR Nouakchott*[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le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Abstract]))</a:t>
                      </a:r>
                      <a:endParaRPr lang="en-CA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7283210"/>
                  </a:ext>
                </a:extLst>
              </a:tr>
              <a:tr h="92979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oogle Scholar</a:t>
                      </a:r>
                      <a:endParaRPr lang="en-CA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buNone/>
                      </a:pP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BV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HBV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type b" OR "type b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" OR "hep b") AND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Nouakchott)</a:t>
                      </a:r>
                      <a:b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</a:b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DV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HDV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type d" OR "type d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" OR "hep d") AND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Nouakchott)</a:t>
                      </a:r>
                      <a:b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</a:b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BV-HDV co-infection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HBV) AND 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HDV) AND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Nouakchott)</a:t>
                      </a:r>
                      <a:endParaRPr lang="en-CA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0699073"/>
                  </a:ext>
                </a:extLst>
              </a:tr>
              <a:tr h="1120361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opus </a:t>
                      </a:r>
                      <a:endParaRPr lang="en-CA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CA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buNone/>
                      </a:pP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BV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HBV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type b" OR "type b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" OR "hep b") AND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 OR Nouakchott*)</a:t>
                      </a:r>
                      <a:b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</a:b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DV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HDV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type d" OR "type d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" OR "hep d") AND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 OR Nouakchott*)</a:t>
                      </a:r>
                      <a:b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</a:b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BV-HDV co-infection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HBV) AND 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HDV) AND 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 OR Nouakchott*)</a:t>
                      </a:r>
                      <a:endParaRPr lang="en-CA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6931343"/>
                  </a:ext>
                </a:extLst>
              </a:tr>
              <a:tr h="132149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en-CA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buNone/>
                      </a:pPr>
                      <a:r>
                        <a:rPr lang="fr-FR" sz="10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eb of Science </a:t>
                      </a:r>
                      <a:endParaRPr lang="en-CA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buNone/>
                      </a:pP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BV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S=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HBV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type b" OR "type b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" OR "hep b") AND TS=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Nouakchott)</a:t>
                      </a:r>
                      <a:b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</a:b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DV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S=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HDV OR 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type d" OR "type d 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" OR "hep d") AND TS=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Nouakchott)</a:t>
                      </a:r>
                      <a:b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</a:br>
                      <a:r>
                        <a:rPr lang="fr-FR" sz="1000" b="1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BV-HDV co-infection: 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S=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B" OR HBV) AND TS=("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patitis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D" OR HDV) AND TS=(</a:t>
                      </a:r>
                      <a:r>
                        <a:rPr lang="fr-FR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uritania</a:t>
                      </a:r>
                      <a:r>
                        <a:rPr lang="fr-FR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Nouakchott)</a:t>
                      </a:r>
                      <a:endParaRPr lang="en-CA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0368" marR="4036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5173822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9D251B17-452F-4EBC-E8F5-3AFE76C5D5D6}"/>
              </a:ext>
            </a:extLst>
          </p:cNvPr>
          <p:cNvSpPr txBox="1"/>
          <p:nvPr/>
        </p:nvSpPr>
        <p:spPr>
          <a:xfrm>
            <a:off x="448733" y="133017"/>
            <a:ext cx="9435496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200" b="1" u="none" strike="noStrike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r>
              <a:rPr lang="en-US" sz="1200" b="1" u="sng" strike="noStrike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</a:t>
            </a:r>
            <a:r>
              <a:rPr lang="en-US" sz="1200" b="1" u="sng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able 1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Search terms for online databases used in the systematic review of HBV and HDV information in Mauritania.</a:t>
            </a:r>
            <a:endParaRPr lang="en-CA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B1E0B53C-BD4E-1718-7797-18AE88C23C1F}"/>
              </a:ext>
            </a:extLst>
          </p:cNvPr>
          <p:cNvSpPr txBox="1"/>
          <p:nvPr/>
        </p:nvSpPr>
        <p:spPr>
          <a:xfrm>
            <a:off x="8116148" y="5681941"/>
            <a:ext cx="34256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kern="100" dirty="0" err="1">
                <a:latin typeface="Arial" panose="020B0604020202020204" pitchFamily="34" charset="0"/>
                <a:cs typeface="Arial" panose="020B0604020202020204" pitchFamily="34" charset="0"/>
              </a:rPr>
              <a:t>Abbreviations</a:t>
            </a:r>
            <a:r>
              <a:rPr lang="fr-F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 :</a:t>
            </a:r>
          </a:p>
          <a:p>
            <a:r>
              <a:rPr lang="en-US" sz="1000" kern="100" dirty="0">
                <a:latin typeface="Arial" panose="020B0604020202020204" pitchFamily="34" charset="0"/>
                <a:cs typeface="Arial" panose="020B0604020202020204" pitchFamily="34" charset="0"/>
              </a:rPr>
              <a:t>HBV: Hepatitis B Virus, HDV: Hepatitis D Virus, TS: Topic Search (Web of Science), *: Truncation to include all word variants, </a:t>
            </a:r>
            <a:r>
              <a:rPr lang="en-US" sz="1000" kern="100" dirty="0" err="1">
                <a:latin typeface="Arial" panose="020B0604020202020204" pitchFamily="34" charset="0"/>
                <a:cs typeface="Arial" panose="020B0604020202020204" pitchFamily="34" charset="0"/>
              </a:rPr>
              <a:t>MeSH</a:t>
            </a:r>
            <a:r>
              <a:rPr lang="en-US" sz="1000" kern="100" dirty="0">
                <a:latin typeface="Arial" panose="020B0604020202020204" pitchFamily="34" charset="0"/>
                <a:cs typeface="Arial" panose="020B0604020202020204" pitchFamily="34" charset="0"/>
              </a:rPr>
              <a:t> = Medical Subject Headings</a:t>
            </a:r>
            <a:endParaRPr lang="fr-US" sz="10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96147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0">
            <a:extLst>
              <a:ext uri="{FF2B5EF4-FFF2-40B4-BE49-F238E27FC236}">
                <a16:creationId xmlns:a16="http://schemas.microsoft.com/office/drawing/2014/main" id="{E8C9F98A-B2DA-1FEC-EA2C-5795A78F71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249" y="5798642"/>
            <a:ext cx="1063054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. 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verage of 3rd hepatitis B birth-dose vaccination coverage in Mauritania, according to WHO and UNICEF reporting data.</a:t>
            </a:r>
            <a:endParaRPr kumimoji="0" lang="en-CA" alt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Graphique 1">
            <a:extLst>
              <a:ext uri="{FF2B5EF4-FFF2-40B4-BE49-F238E27FC236}">
                <a16:creationId xmlns:a16="http://schemas.microsoft.com/office/drawing/2014/main" id="{713F22F5-35D0-9FD6-3BB4-0E33007898E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01060038"/>
              </p:ext>
            </p:extLst>
          </p:nvPr>
        </p:nvGraphicFramePr>
        <p:xfrm>
          <a:off x="1126067" y="1175067"/>
          <a:ext cx="6616488" cy="41250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03678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7</TotalTime>
  <Words>586</Words>
  <Application>Microsoft Office PowerPoint</Application>
  <PresentationFormat>Widescreen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anessa Meier-Stephenson</dc:creator>
  <cp:lastModifiedBy>Miralona Pableo</cp:lastModifiedBy>
  <cp:revision>19</cp:revision>
  <dcterms:created xsi:type="dcterms:W3CDTF">2025-12-17T18:07:15Z</dcterms:created>
  <dcterms:modified xsi:type="dcterms:W3CDTF">2026-04-10T02:06:00Z</dcterms:modified>
</cp:coreProperties>
</file>